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335713" cy="84597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1" d="100"/>
          <a:sy n="91" d="100"/>
        </p:scale>
        <p:origin x="291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5179" y="1384507"/>
            <a:ext cx="5385356" cy="2945260"/>
          </a:xfrm>
        </p:spPr>
        <p:txBody>
          <a:bodyPr anchor="b"/>
          <a:lstStyle>
            <a:lvl1pPr algn="ctr">
              <a:defRPr sz="415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91964" y="4443348"/>
            <a:ext cx="4751785" cy="2042490"/>
          </a:xfrm>
        </p:spPr>
        <p:txBody>
          <a:bodyPr/>
          <a:lstStyle>
            <a:lvl1pPr marL="0" indent="0" algn="ctr">
              <a:buNone/>
              <a:defRPr sz="1663"/>
            </a:lvl1pPr>
            <a:lvl2pPr marL="316794" indent="0" algn="ctr">
              <a:buNone/>
              <a:defRPr sz="1386"/>
            </a:lvl2pPr>
            <a:lvl3pPr marL="633588" indent="0" algn="ctr">
              <a:buNone/>
              <a:defRPr sz="1247"/>
            </a:lvl3pPr>
            <a:lvl4pPr marL="950382" indent="0" algn="ctr">
              <a:buNone/>
              <a:defRPr sz="1109"/>
            </a:lvl4pPr>
            <a:lvl5pPr marL="1267176" indent="0" algn="ctr">
              <a:buNone/>
              <a:defRPr sz="1109"/>
            </a:lvl5pPr>
            <a:lvl6pPr marL="1583969" indent="0" algn="ctr">
              <a:buNone/>
              <a:defRPr sz="1109"/>
            </a:lvl6pPr>
            <a:lvl7pPr marL="1900763" indent="0" algn="ctr">
              <a:buNone/>
              <a:defRPr sz="1109"/>
            </a:lvl7pPr>
            <a:lvl8pPr marL="2217557" indent="0" algn="ctr">
              <a:buNone/>
              <a:defRPr sz="1109"/>
            </a:lvl8pPr>
            <a:lvl9pPr marL="2534351" indent="0" algn="ctr">
              <a:buNone/>
              <a:defRPr sz="1109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4258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9675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33995" y="450406"/>
            <a:ext cx="1366138" cy="716927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5581" y="450406"/>
            <a:ext cx="4019218" cy="716927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682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2373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2281" y="2109075"/>
            <a:ext cx="5464552" cy="3519036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2281" y="5661402"/>
            <a:ext cx="5464552" cy="1850578"/>
          </a:xfrm>
        </p:spPr>
        <p:txBody>
          <a:bodyPr/>
          <a:lstStyle>
            <a:lvl1pPr marL="0" indent="0">
              <a:buNone/>
              <a:defRPr sz="1663">
                <a:solidFill>
                  <a:schemeClr val="tx1"/>
                </a:solidFill>
              </a:defRPr>
            </a:lvl1pPr>
            <a:lvl2pPr marL="31679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2pPr>
            <a:lvl3pPr marL="633588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3pPr>
            <a:lvl4pPr marL="950382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4pPr>
            <a:lvl5pPr marL="1267176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5pPr>
            <a:lvl6pPr marL="1583969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6pPr>
            <a:lvl7pPr marL="1900763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7pPr>
            <a:lvl8pPr marL="2217557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8pPr>
            <a:lvl9pPr marL="2534351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0897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5580" y="2252027"/>
            <a:ext cx="2692678" cy="536765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7455" y="2252027"/>
            <a:ext cx="2692678" cy="536765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361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406" y="450407"/>
            <a:ext cx="5464552" cy="163516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406" y="2073824"/>
            <a:ext cx="2680303" cy="1016349"/>
          </a:xfrm>
        </p:spPr>
        <p:txBody>
          <a:bodyPr anchor="b"/>
          <a:lstStyle>
            <a:lvl1pPr marL="0" indent="0">
              <a:buNone/>
              <a:defRPr sz="1663" b="1"/>
            </a:lvl1pPr>
            <a:lvl2pPr marL="316794" indent="0">
              <a:buNone/>
              <a:defRPr sz="1386" b="1"/>
            </a:lvl2pPr>
            <a:lvl3pPr marL="633588" indent="0">
              <a:buNone/>
              <a:defRPr sz="1247" b="1"/>
            </a:lvl3pPr>
            <a:lvl4pPr marL="950382" indent="0">
              <a:buNone/>
              <a:defRPr sz="1109" b="1"/>
            </a:lvl4pPr>
            <a:lvl5pPr marL="1267176" indent="0">
              <a:buNone/>
              <a:defRPr sz="1109" b="1"/>
            </a:lvl5pPr>
            <a:lvl6pPr marL="1583969" indent="0">
              <a:buNone/>
              <a:defRPr sz="1109" b="1"/>
            </a:lvl6pPr>
            <a:lvl7pPr marL="1900763" indent="0">
              <a:buNone/>
              <a:defRPr sz="1109" b="1"/>
            </a:lvl7pPr>
            <a:lvl8pPr marL="2217557" indent="0">
              <a:buNone/>
              <a:defRPr sz="1109" b="1"/>
            </a:lvl8pPr>
            <a:lvl9pPr marL="2534351" indent="0">
              <a:buNone/>
              <a:defRPr sz="1109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6406" y="3090173"/>
            <a:ext cx="2680303" cy="454517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07455" y="2073824"/>
            <a:ext cx="2693503" cy="1016349"/>
          </a:xfrm>
        </p:spPr>
        <p:txBody>
          <a:bodyPr anchor="b"/>
          <a:lstStyle>
            <a:lvl1pPr marL="0" indent="0">
              <a:buNone/>
              <a:defRPr sz="1663" b="1"/>
            </a:lvl1pPr>
            <a:lvl2pPr marL="316794" indent="0">
              <a:buNone/>
              <a:defRPr sz="1386" b="1"/>
            </a:lvl2pPr>
            <a:lvl3pPr marL="633588" indent="0">
              <a:buNone/>
              <a:defRPr sz="1247" b="1"/>
            </a:lvl3pPr>
            <a:lvl4pPr marL="950382" indent="0">
              <a:buNone/>
              <a:defRPr sz="1109" b="1"/>
            </a:lvl4pPr>
            <a:lvl5pPr marL="1267176" indent="0">
              <a:buNone/>
              <a:defRPr sz="1109" b="1"/>
            </a:lvl5pPr>
            <a:lvl6pPr marL="1583969" indent="0">
              <a:buNone/>
              <a:defRPr sz="1109" b="1"/>
            </a:lvl6pPr>
            <a:lvl7pPr marL="1900763" indent="0">
              <a:buNone/>
              <a:defRPr sz="1109" b="1"/>
            </a:lvl7pPr>
            <a:lvl8pPr marL="2217557" indent="0">
              <a:buNone/>
              <a:defRPr sz="1109" b="1"/>
            </a:lvl8pPr>
            <a:lvl9pPr marL="2534351" indent="0">
              <a:buNone/>
              <a:defRPr sz="1109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07455" y="3090173"/>
            <a:ext cx="2693503" cy="454517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835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0304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46225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406" y="563986"/>
            <a:ext cx="2043432" cy="1973951"/>
          </a:xfrm>
        </p:spPr>
        <p:txBody>
          <a:bodyPr anchor="b"/>
          <a:lstStyle>
            <a:lvl1pPr>
              <a:defRPr sz="221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93503" y="1218054"/>
            <a:ext cx="3207455" cy="6011933"/>
          </a:xfrm>
        </p:spPr>
        <p:txBody>
          <a:bodyPr/>
          <a:lstStyle>
            <a:lvl1pPr>
              <a:defRPr sz="2217"/>
            </a:lvl1pPr>
            <a:lvl2pPr>
              <a:defRPr sz="1940"/>
            </a:lvl2pPr>
            <a:lvl3pPr>
              <a:defRPr sz="1663"/>
            </a:lvl3pPr>
            <a:lvl4pPr>
              <a:defRPr sz="1386"/>
            </a:lvl4pPr>
            <a:lvl5pPr>
              <a:defRPr sz="1386"/>
            </a:lvl5pPr>
            <a:lvl6pPr>
              <a:defRPr sz="1386"/>
            </a:lvl6pPr>
            <a:lvl7pPr>
              <a:defRPr sz="1386"/>
            </a:lvl7pPr>
            <a:lvl8pPr>
              <a:defRPr sz="1386"/>
            </a:lvl8pPr>
            <a:lvl9pPr>
              <a:defRPr sz="138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6406" y="2537936"/>
            <a:ext cx="2043432" cy="4701841"/>
          </a:xfrm>
        </p:spPr>
        <p:txBody>
          <a:bodyPr/>
          <a:lstStyle>
            <a:lvl1pPr marL="0" indent="0">
              <a:buNone/>
              <a:defRPr sz="1109"/>
            </a:lvl1pPr>
            <a:lvl2pPr marL="316794" indent="0">
              <a:buNone/>
              <a:defRPr sz="970"/>
            </a:lvl2pPr>
            <a:lvl3pPr marL="633588" indent="0">
              <a:buNone/>
              <a:defRPr sz="831"/>
            </a:lvl3pPr>
            <a:lvl4pPr marL="950382" indent="0">
              <a:buNone/>
              <a:defRPr sz="693"/>
            </a:lvl4pPr>
            <a:lvl5pPr marL="1267176" indent="0">
              <a:buNone/>
              <a:defRPr sz="693"/>
            </a:lvl5pPr>
            <a:lvl6pPr marL="1583969" indent="0">
              <a:buNone/>
              <a:defRPr sz="693"/>
            </a:lvl6pPr>
            <a:lvl7pPr marL="1900763" indent="0">
              <a:buNone/>
              <a:defRPr sz="693"/>
            </a:lvl7pPr>
            <a:lvl8pPr marL="2217557" indent="0">
              <a:buNone/>
              <a:defRPr sz="693"/>
            </a:lvl8pPr>
            <a:lvl9pPr marL="2534351" indent="0">
              <a:buNone/>
              <a:defRPr sz="69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2710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406" y="563986"/>
            <a:ext cx="2043432" cy="1973951"/>
          </a:xfrm>
        </p:spPr>
        <p:txBody>
          <a:bodyPr anchor="b"/>
          <a:lstStyle>
            <a:lvl1pPr>
              <a:defRPr sz="221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93503" y="1218054"/>
            <a:ext cx="3207455" cy="6011933"/>
          </a:xfrm>
        </p:spPr>
        <p:txBody>
          <a:bodyPr anchor="t"/>
          <a:lstStyle>
            <a:lvl1pPr marL="0" indent="0">
              <a:buNone/>
              <a:defRPr sz="2217"/>
            </a:lvl1pPr>
            <a:lvl2pPr marL="316794" indent="0">
              <a:buNone/>
              <a:defRPr sz="1940"/>
            </a:lvl2pPr>
            <a:lvl3pPr marL="633588" indent="0">
              <a:buNone/>
              <a:defRPr sz="1663"/>
            </a:lvl3pPr>
            <a:lvl4pPr marL="950382" indent="0">
              <a:buNone/>
              <a:defRPr sz="1386"/>
            </a:lvl4pPr>
            <a:lvl5pPr marL="1267176" indent="0">
              <a:buNone/>
              <a:defRPr sz="1386"/>
            </a:lvl5pPr>
            <a:lvl6pPr marL="1583969" indent="0">
              <a:buNone/>
              <a:defRPr sz="1386"/>
            </a:lvl6pPr>
            <a:lvl7pPr marL="1900763" indent="0">
              <a:buNone/>
              <a:defRPr sz="1386"/>
            </a:lvl7pPr>
            <a:lvl8pPr marL="2217557" indent="0">
              <a:buNone/>
              <a:defRPr sz="1386"/>
            </a:lvl8pPr>
            <a:lvl9pPr marL="2534351" indent="0">
              <a:buNone/>
              <a:defRPr sz="1386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6406" y="2537936"/>
            <a:ext cx="2043432" cy="4701841"/>
          </a:xfrm>
        </p:spPr>
        <p:txBody>
          <a:bodyPr/>
          <a:lstStyle>
            <a:lvl1pPr marL="0" indent="0">
              <a:buNone/>
              <a:defRPr sz="1109"/>
            </a:lvl1pPr>
            <a:lvl2pPr marL="316794" indent="0">
              <a:buNone/>
              <a:defRPr sz="970"/>
            </a:lvl2pPr>
            <a:lvl3pPr marL="633588" indent="0">
              <a:buNone/>
              <a:defRPr sz="831"/>
            </a:lvl3pPr>
            <a:lvl4pPr marL="950382" indent="0">
              <a:buNone/>
              <a:defRPr sz="693"/>
            </a:lvl4pPr>
            <a:lvl5pPr marL="1267176" indent="0">
              <a:buNone/>
              <a:defRPr sz="693"/>
            </a:lvl5pPr>
            <a:lvl6pPr marL="1583969" indent="0">
              <a:buNone/>
              <a:defRPr sz="693"/>
            </a:lvl6pPr>
            <a:lvl7pPr marL="1900763" indent="0">
              <a:buNone/>
              <a:defRPr sz="693"/>
            </a:lvl7pPr>
            <a:lvl8pPr marL="2217557" indent="0">
              <a:buNone/>
              <a:defRPr sz="693"/>
            </a:lvl8pPr>
            <a:lvl9pPr marL="2534351" indent="0">
              <a:buNone/>
              <a:defRPr sz="69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681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5581" y="450407"/>
            <a:ext cx="5464552" cy="16351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5581" y="2252027"/>
            <a:ext cx="5464552" cy="536765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5580" y="7840972"/>
            <a:ext cx="1425535" cy="4504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885406-E0F7-4D14-8AE4-4C72B5EA336C}" type="datetimeFigureOut">
              <a:rPr lang="en-GB" smtClean="0"/>
              <a:t>03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98705" y="7840972"/>
            <a:ext cx="2138303" cy="4504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74598" y="7840972"/>
            <a:ext cx="1425535" cy="4504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60C435-0291-4A53-94E3-D4E002FBE0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0115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33588" rtl="0" eaLnBrk="1" latinLnBrk="0" hangingPunct="1">
        <a:lnSpc>
          <a:spcPct val="90000"/>
        </a:lnSpc>
        <a:spcBef>
          <a:spcPct val="0"/>
        </a:spcBef>
        <a:buNone/>
        <a:defRPr sz="304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397" indent="-158397" algn="l" defTabSz="633588" rtl="0" eaLnBrk="1" latinLnBrk="0" hangingPunct="1">
        <a:lnSpc>
          <a:spcPct val="90000"/>
        </a:lnSpc>
        <a:spcBef>
          <a:spcPts val="693"/>
        </a:spcBef>
        <a:buFont typeface="Arial" panose="020B0604020202020204" pitchFamily="34" charset="0"/>
        <a:buChar char="•"/>
        <a:defRPr sz="1940" kern="1200">
          <a:solidFill>
            <a:schemeClr val="tx1"/>
          </a:solidFill>
          <a:latin typeface="+mn-lt"/>
          <a:ea typeface="+mn-ea"/>
          <a:cs typeface="+mn-cs"/>
        </a:defRPr>
      </a:lvl1pPr>
      <a:lvl2pPr marL="475191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663" kern="1200">
          <a:solidFill>
            <a:schemeClr val="tx1"/>
          </a:solidFill>
          <a:latin typeface="+mn-lt"/>
          <a:ea typeface="+mn-ea"/>
          <a:cs typeface="+mn-cs"/>
        </a:defRPr>
      </a:lvl2pPr>
      <a:lvl3pPr marL="791985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3pPr>
      <a:lvl4pPr marL="1108779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4pPr>
      <a:lvl5pPr marL="1425572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5pPr>
      <a:lvl6pPr marL="1742366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6pPr>
      <a:lvl7pPr marL="2059160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7pPr>
      <a:lvl8pPr marL="2375954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8pPr>
      <a:lvl9pPr marL="2692748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1pPr>
      <a:lvl2pPr marL="316794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2pPr>
      <a:lvl3pPr marL="633588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3pPr>
      <a:lvl4pPr marL="950382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4pPr>
      <a:lvl5pPr marL="1267176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5pPr>
      <a:lvl6pPr marL="1583969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6pPr>
      <a:lvl7pPr marL="1900763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7pPr>
      <a:lvl8pPr marL="2217557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8pPr>
      <a:lvl9pPr marL="2534351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7883940"/>
              </p:ext>
            </p:extLst>
          </p:nvPr>
        </p:nvGraphicFramePr>
        <p:xfrm>
          <a:off x="298174" y="730608"/>
          <a:ext cx="5705061" cy="3882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16864"/>
                <a:gridCol w="2323489"/>
                <a:gridCol w="2264708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me fragment (</a:t>
                      </a:r>
                      <a:r>
                        <a:rPr lang="en-GB" sz="11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</a:t>
                      </a: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r>
                        <a:rPr lang="en-GB" sz="1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imer</a:t>
                      </a:r>
                      <a:endParaRPr lang="en-GB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</a:t>
                      </a:r>
                      <a:endParaRPr lang="en-GB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-1260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TGTACGTGGACATAGAC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CCACTTACTGAAGGCTT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1-2255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AGACGGATTCCTGATGT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CCAGATCCCGGTACTCC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9-3281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ACACCATATTGCGATGCA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CGCTGTCTAGATCCAC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15-4326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ACTATTAAGGAGTGGGA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CGGTCCCCTTCAGACT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40-5270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AGCCTTCGTAGGACAGGT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GTACGGTGCTCATTAC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1-6270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CTATTTGACCACAACGT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CTGCCAGTACATTCT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0-7244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GTCCGATTGTCCAATCC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GCGGGTCTGCCACTCT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91-8261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ACATCACCATCGCCAGC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TCCTCCTAAGACTATGG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96-9230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TCGATAACGCGGACCTGG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GACCGCGGCATGACATT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73-10240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CGCAGCACGGTAAAGAG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GTGAAGACCTTACAGCT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62-11240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AATGAGCGTCGGTGCCCA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TCCCGTGATCTTCTGCAC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l"/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61-11790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AAGAAAGGCAAGTGTGC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t-EE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TCTCCTACGTCCCTGTGG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60150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45</Words>
  <Application>Microsoft Office PowerPoint</Application>
  <PresentationFormat>Custom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ni Gao</dc:creator>
  <cp:lastModifiedBy>Mark Harris</cp:lastModifiedBy>
  <cp:revision>12</cp:revision>
  <dcterms:created xsi:type="dcterms:W3CDTF">2018-11-30T18:53:35Z</dcterms:created>
  <dcterms:modified xsi:type="dcterms:W3CDTF">2019-01-03T10:35:20Z</dcterms:modified>
</cp:coreProperties>
</file>